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ink/ink1.xml" ContentType="application/inkml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32" r:id="rId1"/>
  </p:sldMasterIdLst>
  <p:notesMasterIdLst>
    <p:notesMasterId r:id="rId3"/>
  </p:notesMasterIdLst>
  <p:sldIdLst>
    <p:sldId id="270" r:id="rId2"/>
  </p:sldIdLst>
  <p:sldSz cx="7559675" cy="10439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7EFDE27-64D2-9A47-7EBA-F4D877437D86}" name="Crevel, Reinout van" initials="" userId="S::Reinout.vanCrevel@radboudumc.nl::c8a85eab-04e2-4374-80ac-ff56393b1662" providerId="AD"/>
  <p188:author id="{0A69D33C-A3AE-B2FD-DAE3-489C6085493B}" name="Setiabudiawan, Todia" initials="TS" userId="S::Todia.Setiabudiawan@radboudumc.nl::b66113ee-6b80-4b22-902e-4e4411cc18e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7335"/>
    <p:restoredTop sz="94720"/>
  </p:normalViewPr>
  <p:slideViewPr>
    <p:cSldViewPr snapToGrid="0">
      <p:cViewPr varScale="1">
        <p:scale>
          <a:sx n="67" d="100"/>
          <a:sy n="67" d="100"/>
        </p:scale>
        <p:origin x="240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7-31T04:34:05.396"/>
    </inkml:context>
    <inkml:brush xml:id="br0">
      <inkml:brushProperty name="width" value="0.025" units="cm"/>
      <inkml:brushProperty name="height" value="0.025" units="cm"/>
      <inkml:brushProperty name="color" value="#E71224"/>
    </inkml:brush>
  </inkml:definitions>
  <inkml:trace contextRef="#ctx0" brushRef="#br0">0 1 24575,'0'0'0</inkml:trace>
</inkml:ink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D36B6E-0244-7342-9A93-7D998A0B8A7C}" type="datetimeFigureOut">
              <a:rPr lang="en-US" smtClean="0"/>
              <a:t>3/30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11400" y="1143000"/>
            <a:ext cx="22352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6B7A9C-8B5B-7A4D-836E-05FD47B04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4364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A183006-CBCD-FD37-434B-EA1D527B720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AEE8AA14-6B1F-3917-82C4-B58E7A50550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311400" y="1143000"/>
            <a:ext cx="2235200" cy="3086100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FB1F3AA0-E265-E3D3-E12D-CE39D41FDAD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1388CEC-0E71-6C0A-0C1D-C482EEB55DC2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A6B7A9C-8B5B-7A4D-836E-05FD47B04D2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9428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08486"/>
            <a:ext cx="6425724" cy="3634458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483102"/>
            <a:ext cx="5669756" cy="2520438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011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777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55801"/>
            <a:ext cx="1630055" cy="8846909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55801"/>
            <a:ext cx="4795669" cy="8846909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8843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552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02603"/>
            <a:ext cx="6520220" cy="4342500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986185"/>
            <a:ext cx="6520220" cy="2283618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>
                    <a:tint val="82000"/>
                  </a:schemeClr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82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82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116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779007"/>
            <a:ext cx="3212862" cy="662370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779007"/>
            <a:ext cx="3212862" cy="662370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37483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55804"/>
            <a:ext cx="6520220" cy="2017801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559104"/>
            <a:ext cx="3198096" cy="12541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813281"/>
            <a:ext cx="3198096" cy="560876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559104"/>
            <a:ext cx="3213847" cy="12541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813281"/>
            <a:ext cx="3213847" cy="560876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129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45652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888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03083"/>
            <a:ext cx="3827085" cy="7418740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2123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03083"/>
            <a:ext cx="3827085" cy="7418740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88030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55804"/>
            <a:ext cx="6520220" cy="20178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779007"/>
            <a:ext cx="6520220" cy="66237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675780"/>
            <a:ext cx="2551390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4421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customXml" Target="../ink/ink1.xml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png"/><Relationship Id="rId5" Type="http://schemas.openxmlformats.org/officeDocument/2006/relationships/image" Target="../media/image1.png"/><Relationship Id="rId10" Type="http://schemas.openxmlformats.org/officeDocument/2006/relationships/image" Target="../media/image6.png"/><Relationship Id="rId4" Type="http://schemas.openxmlformats.org/officeDocument/2006/relationships/image" Target="../media/image16.png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960615C-3575-0DC2-0093-5D38B2D5A03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p14="http://schemas.microsoft.com/office/powerpoint/2010/main">
        <mc:Choice Requires="p14">
          <p:contentPart p14:bwMode="auto" r:id="rId3">
            <p14:nvContentPartPr>
              <p14:cNvPr id="19" name="Ink 18">
                <a:extLst>
                  <a:ext uri="{FF2B5EF4-FFF2-40B4-BE49-F238E27FC236}">
                    <a16:creationId xmlns:a16="http://schemas.microsoft.com/office/drawing/2014/main" id="{894EF4CA-4F67-0D18-4A98-1F076D758A8A}"/>
                  </a:ext>
                </a:extLst>
              </p14:cNvPr>
              <p14:cNvContentPartPr>
                <a14:cpLocks xmlns:a14="http://schemas.microsoft.com/office/drawing/2010/main" noChangeAspect="1"/>
              </p14:cNvContentPartPr>
              <p14:nvPr/>
            </p14:nvContentPartPr>
            <p14:xfrm>
              <a:off x="5235796" y="5772974"/>
              <a:ext cx="311" cy="311"/>
            </p14:xfrm>
          </p:contentPart>
        </mc:Choice>
        <mc:Fallback xmlns="">
          <p:pic>
            <p:nvPicPr>
              <p:cNvPr id="19" name="Ink 18">
                <a:extLst>
                  <a:ext uri="{FF2B5EF4-FFF2-40B4-BE49-F238E27FC236}">
                    <a16:creationId xmlns:a16="http://schemas.microsoft.com/office/drawing/2014/main" id="{894EF4CA-4F67-0D18-4A98-1F076D758A8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232064" y="5769242"/>
                <a:ext cx="7775" cy="7775"/>
              </a:xfrm>
              <a:prstGeom prst="rect">
                <a:avLst/>
              </a:prstGeom>
            </p:spPr>
          </p:pic>
        </mc:Fallback>
      </mc:AlternateContent>
      <p:pic>
        <p:nvPicPr>
          <p:cNvPr id="27" name="Picture 26" descr="A diagram of a number of circles&#10;&#10;Description automatically generated with medium confidence">
            <a:extLst>
              <a:ext uri="{FF2B5EF4-FFF2-40B4-BE49-F238E27FC236}">
                <a16:creationId xmlns:a16="http://schemas.microsoft.com/office/drawing/2014/main" id="{EC1C43AA-0FAD-4F78-69E6-C4B3182B6380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36453" y="292843"/>
            <a:ext cx="2730828" cy="2730827"/>
          </a:xfrm>
          <a:prstGeom prst="rect">
            <a:avLst/>
          </a:prstGeom>
        </p:spPr>
      </p:pic>
      <p:pic>
        <p:nvPicPr>
          <p:cNvPr id="64" name="Picture 63" descr="A graph of a number of cells&#10;&#10;Description automatically generated with medium confidence">
            <a:extLst>
              <a:ext uri="{FF2B5EF4-FFF2-40B4-BE49-F238E27FC236}">
                <a16:creationId xmlns:a16="http://schemas.microsoft.com/office/drawing/2014/main" id="{9006A82C-2CDA-1F70-2E7E-E9EF616B0136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-491" b="-616"/>
          <a:stretch/>
        </p:blipFill>
        <p:spPr>
          <a:xfrm>
            <a:off x="-17814" y="3505632"/>
            <a:ext cx="2337017" cy="3633689"/>
          </a:xfrm>
          <a:prstGeom prst="rect">
            <a:avLst/>
          </a:prstGeom>
        </p:spPr>
      </p:pic>
      <p:pic>
        <p:nvPicPr>
          <p:cNvPr id="68" name="Picture 67" descr="A screen shot of a graph&#10;&#10;Description automatically generated">
            <a:extLst>
              <a:ext uri="{FF2B5EF4-FFF2-40B4-BE49-F238E27FC236}">
                <a16:creationId xmlns:a16="http://schemas.microsoft.com/office/drawing/2014/main" id="{A2B11682-81E2-769E-68E4-337116C6DA0F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418514" y="3505632"/>
            <a:ext cx="2377132" cy="3720057"/>
          </a:xfrm>
          <a:prstGeom prst="rect">
            <a:avLst/>
          </a:prstGeom>
        </p:spPr>
      </p:pic>
      <p:pic>
        <p:nvPicPr>
          <p:cNvPr id="25" name="Picture 24" descr="A diagram of a number&#10;&#10;Description automatically generated">
            <a:extLst>
              <a:ext uri="{FF2B5EF4-FFF2-40B4-BE49-F238E27FC236}">
                <a16:creationId xmlns:a16="http://schemas.microsoft.com/office/drawing/2014/main" id="{2EA19737-52D2-0420-F5E4-0FE0F1BFB4BA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978487" y="292843"/>
            <a:ext cx="2730828" cy="2730828"/>
          </a:xfrm>
          <a:prstGeom prst="rect">
            <a:avLst/>
          </a:prstGeom>
        </p:spPr>
      </p:pic>
      <p:pic>
        <p:nvPicPr>
          <p:cNvPr id="90" name="Picture 89" descr="A graph with red and blue dots&#10;&#10;Description automatically generated">
            <a:extLst>
              <a:ext uri="{FF2B5EF4-FFF2-40B4-BE49-F238E27FC236}">
                <a16:creationId xmlns:a16="http://schemas.microsoft.com/office/drawing/2014/main" id="{79D5C3EF-2C36-68EF-C793-8EE55250E610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894956" y="3505632"/>
            <a:ext cx="2664720" cy="366134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4DF1F02-B237-167D-97EB-B9700BA983DD}"/>
              </a:ext>
            </a:extLst>
          </p:cNvPr>
          <p:cNvSpPr txBox="1"/>
          <p:nvPr/>
        </p:nvSpPr>
        <p:spPr>
          <a:xfrm>
            <a:off x="32424" y="7353437"/>
            <a:ext cx="749482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NZ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Comparison of transcriptional programs associated with IGRA conversion versus early clearance following L2-B exposure.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Picture 6" descr="A diagram of a number of circles&#10;&#10;Description automatically generated with medium confidence">
            <a:extLst>
              <a:ext uri="{FF2B5EF4-FFF2-40B4-BE49-F238E27FC236}">
                <a16:creationId xmlns:a16="http://schemas.microsoft.com/office/drawing/2014/main" id="{7CF70BA2-D755-42E1-DFDB-E663C4677DDC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2846" y="292843"/>
            <a:ext cx="2732400" cy="27324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0C1E793-4D9A-394E-E47C-7773F8512E92}"/>
              </a:ext>
            </a:extLst>
          </p:cNvPr>
          <p:cNvSpPr txBox="1"/>
          <p:nvPr/>
        </p:nvSpPr>
        <p:spPr>
          <a:xfrm>
            <a:off x="-35532" y="157485"/>
            <a:ext cx="276038" cy="2707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59" b="1" dirty="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FBB6219-8721-4ABC-2E2F-6A87EC3C4506}"/>
              </a:ext>
            </a:extLst>
          </p:cNvPr>
          <p:cNvSpPr txBox="1"/>
          <p:nvPr/>
        </p:nvSpPr>
        <p:spPr>
          <a:xfrm>
            <a:off x="-34725" y="3377884"/>
            <a:ext cx="276038" cy="2707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59" b="1" dirty="0"/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3784936-AEDC-8D13-6F80-DB2204EF73CD}"/>
              </a:ext>
            </a:extLst>
          </p:cNvPr>
          <p:cNvSpPr txBox="1"/>
          <p:nvPr/>
        </p:nvSpPr>
        <p:spPr>
          <a:xfrm>
            <a:off x="2432322" y="3377884"/>
            <a:ext cx="290464" cy="2707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59" b="1" dirty="0"/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D4F860D-789D-3431-79CB-FEDC1C65EDDA}"/>
              </a:ext>
            </a:extLst>
          </p:cNvPr>
          <p:cNvSpPr txBox="1"/>
          <p:nvPr/>
        </p:nvSpPr>
        <p:spPr>
          <a:xfrm>
            <a:off x="4913796" y="3377884"/>
            <a:ext cx="290464" cy="2707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59" b="1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1113342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948</TotalTime>
  <Words>24</Words>
  <Application>Microsoft Macintosh PowerPoint</Application>
  <PresentationFormat>Custom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omi Daniels</dc:creator>
  <cp:lastModifiedBy>Naomi Daniels</cp:lastModifiedBy>
  <cp:revision>5</cp:revision>
  <dcterms:created xsi:type="dcterms:W3CDTF">2025-04-08T03:28:33Z</dcterms:created>
  <dcterms:modified xsi:type="dcterms:W3CDTF">2026-03-30T03:32:46Z</dcterms:modified>
</cp:coreProperties>
</file>